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696" r:id="rId2"/>
    <p:sldId id="697" r:id="rId3"/>
    <p:sldId id="693" r:id="rId4"/>
    <p:sldId id="698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0432FF"/>
    <a:srgbClr val="8EFA00"/>
    <a:srgbClr val="941100"/>
    <a:srgbClr val="FF7E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5266"/>
    <p:restoredTop sz="96301"/>
  </p:normalViewPr>
  <p:slideViewPr>
    <p:cSldViewPr snapToGrid="0" snapToObjects="1">
      <p:cViewPr varScale="1">
        <p:scale>
          <a:sx n="85" d="100"/>
          <a:sy n="85" d="100"/>
        </p:scale>
        <p:origin x="420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 dirty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09432-40B6-6A45-9B64-650E109061FA}" type="datetimeFigureOut">
              <a:t>1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B0D6E-71A3-3146-A915-6D7B6956FD48}" type="slidenum">
              <a:rPr lang="en-AU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234868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09432-40B6-6A45-9B64-650E109061FA}" type="datetimeFigureOut">
              <a:t>1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B0D6E-71A3-3146-A915-6D7B6956FD48}" type="slidenum">
              <a:rPr lang="en-AU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540368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09432-40B6-6A45-9B64-650E109061FA}" type="datetimeFigureOut">
              <a:t>1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B0D6E-71A3-3146-A915-6D7B6956FD48}" type="slidenum">
              <a:rPr lang="en-AU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75695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09432-40B6-6A45-9B64-650E109061FA}" type="datetimeFigureOut">
              <a:t>1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B0D6E-71A3-3146-A915-6D7B6956FD48}" type="slidenum">
              <a:rPr lang="en-AU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742729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dirty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09432-40B6-6A45-9B64-650E109061FA}" type="datetimeFigureOut">
              <a:t>1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B0D6E-71A3-3146-A915-6D7B6956FD48}" type="slidenum">
              <a:rPr lang="en-AU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041098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09432-40B6-6A45-9B64-650E109061FA}" type="datetimeFigureOut">
              <a:t>1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B0D6E-71A3-3146-A915-6D7B6956FD48}" type="slidenum">
              <a:rPr lang="en-AU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858894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 dirty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 dirty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09432-40B6-6A45-9B64-650E109061FA}" type="datetimeFigureOut">
              <a:t>1/10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B0D6E-71A3-3146-A915-6D7B6956FD48}" type="slidenum">
              <a:rPr lang="en-AU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125391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09432-40B6-6A45-9B64-650E109061FA}" type="datetimeFigureOut">
              <a:t>1/10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B0D6E-71A3-3146-A915-6D7B6956FD48}" type="slidenum">
              <a:rPr lang="en-AU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171298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09432-40B6-6A45-9B64-650E109061FA}" type="datetimeFigureOut">
              <a:t>1/10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B0D6E-71A3-3146-A915-6D7B6956FD48}" type="slidenum">
              <a:rPr lang="en-AU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7710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09432-40B6-6A45-9B64-650E109061FA}" type="datetimeFigureOut">
              <a:t>1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B0D6E-71A3-3146-A915-6D7B6956FD48}" type="slidenum">
              <a:rPr lang="en-AU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37684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 dirty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09432-40B6-6A45-9B64-650E109061FA}" type="datetimeFigureOut">
              <a:t>1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B0D6E-71A3-3146-A915-6D7B6956FD48}" type="slidenum">
              <a:rPr lang="en-AU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39564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509432-40B6-6A45-9B64-650E109061FA}" type="datetimeFigureOut">
              <a:t>1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0B0D6E-71A3-3146-A915-6D7B6956FD48}" type="slidenum">
              <a:rPr lang="en-AU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587547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tif"/><Relationship Id="rId3" Type="http://schemas.openxmlformats.org/officeDocument/2006/relationships/image" Target="../media/image14.tif"/><Relationship Id="rId7" Type="http://schemas.openxmlformats.org/officeDocument/2006/relationships/image" Target="../media/image18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emf"/><Relationship Id="rId11" Type="http://schemas.openxmlformats.org/officeDocument/2006/relationships/image" Target="../media/image22.emf"/><Relationship Id="rId5" Type="http://schemas.openxmlformats.org/officeDocument/2006/relationships/image" Target="../media/image16.emf"/><Relationship Id="rId10" Type="http://schemas.openxmlformats.org/officeDocument/2006/relationships/image" Target="../media/image21.emf"/><Relationship Id="rId4" Type="http://schemas.openxmlformats.org/officeDocument/2006/relationships/image" Target="../media/image15.tif"/><Relationship Id="rId9" Type="http://schemas.openxmlformats.org/officeDocument/2006/relationships/image" Target="../media/image20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5FDB221-9A62-365B-9C00-E8A7217B029A}"/>
              </a:ext>
            </a:extLst>
          </p:cNvPr>
          <p:cNvSpPr txBox="1"/>
          <p:nvPr/>
        </p:nvSpPr>
        <p:spPr>
          <a:xfrm>
            <a:off x="167703" y="141496"/>
            <a:ext cx="18854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400" dirty="0">
                <a:latin typeface="Helvetica" pitchFamily="2" charset="0"/>
              </a:rPr>
              <a:t>Supplementary Fig. 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B379088-2485-4F40-9CA5-D958E90432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36313"/>
            <a:ext cx="6858000" cy="51403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04671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38A4B28-79D4-3FE0-E9DD-505A3AB1D4B9}"/>
              </a:ext>
            </a:extLst>
          </p:cNvPr>
          <p:cNvSpPr txBox="1"/>
          <p:nvPr/>
        </p:nvSpPr>
        <p:spPr>
          <a:xfrm>
            <a:off x="167703" y="141496"/>
            <a:ext cx="18854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400" dirty="0">
                <a:latin typeface="Helvetica" pitchFamily="2" charset="0"/>
              </a:rPr>
              <a:t>Supplementary Fig. 2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A32CAF4-55DC-0C1C-297B-D7AB5CB3C7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0243" y="1031086"/>
            <a:ext cx="1809780" cy="192780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AD3B22B-A9A1-3A90-DA00-09BC1966B965}"/>
              </a:ext>
            </a:extLst>
          </p:cNvPr>
          <p:cNvSpPr txBox="1"/>
          <p:nvPr/>
        </p:nvSpPr>
        <p:spPr>
          <a:xfrm>
            <a:off x="215652" y="53035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dirty="0">
                <a:latin typeface="Helvetica" pitchFamily="2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9AE4EA8-C551-94E6-80E3-9057747C9B93}"/>
              </a:ext>
            </a:extLst>
          </p:cNvPr>
          <p:cNvSpPr txBox="1"/>
          <p:nvPr/>
        </p:nvSpPr>
        <p:spPr>
          <a:xfrm>
            <a:off x="1976814" y="56140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dirty="0">
                <a:latin typeface="Helvetica" pitchFamily="2" charset="0"/>
              </a:rPr>
              <a:t>b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6DD542AD-4020-E622-E766-76CB9FAD65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2559" y="3208406"/>
            <a:ext cx="1714195" cy="202996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9D5C9A9-667E-D401-4728-0C3CA71AD12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61966" y="657527"/>
            <a:ext cx="749300" cy="5334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7AFA175F-8307-5957-7290-C4CFD638D02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99248" y="3213297"/>
            <a:ext cx="1714195" cy="201869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CA793AD-0890-CE90-2479-CCB8BFB8C25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56055" y="3281003"/>
            <a:ext cx="1744721" cy="192780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C7CF0841-7BD8-8364-D4B7-1931AE919F49}"/>
              </a:ext>
            </a:extLst>
          </p:cNvPr>
          <p:cNvSpPr txBox="1"/>
          <p:nvPr/>
        </p:nvSpPr>
        <p:spPr>
          <a:xfrm>
            <a:off x="220992" y="296592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dirty="0">
                <a:latin typeface="Helvetica" pitchFamily="2" charset="0"/>
              </a:rPr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19B8D09-2CA2-8359-08BA-E61621557462}"/>
              </a:ext>
            </a:extLst>
          </p:cNvPr>
          <p:cNvSpPr txBox="1"/>
          <p:nvPr/>
        </p:nvSpPr>
        <p:spPr>
          <a:xfrm>
            <a:off x="3871682" y="296872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dirty="0">
                <a:latin typeface="Helvetica" pitchFamily="2" charset="0"/>
              </a:rPr>
              <a:t>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229A2BB-AC82-985A-E357-FE254D8A578E}"/>
              </a:ext>
            </a:extLst>
          </p:cNvPr>
          <p:cNvSpPr txBox="1"/>
          <p:nvPr/>
        </p:nvSpPr>
        <p:spPr>
          <a:xfrm>
            <a:off x="215652" y="5241338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dirty="0">
                <a:latin typeface="Helvetica" pitchFamily="2" charset="0"/>
              </a:rPr>
              <a:t>f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C4AAE18-867E-451A-E609-2681C553979F}"/>
              </a:ext>
            </a:extLst>
          </p:cNvPr>
          <p:cNvSpPr txBox="1"/>
          <p:nvPr/>
        </p:nvSpPr>
        <p:spPr>
          <a:xfrm>
            <a:off x="2299880" y="524133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dirty="0">
                <a:latin typeface="Helvetica" pitchFamily="2" charset="0"/>
              </a:rPr>
              <a:t>g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DD7EE8C4-0F54-376B-A194-5E37383991A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48666" y="5490393"/>
            <a:ext cx="1830334" cy="1927808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517A51AA-D5C2-A190-0D02-830D66F4885D}"/>
              </a:ext>
            </a:extLst>
          </p:cNvPr>
          <p:cNvSpPr txBox="1"/>
          <p:nvPr/>
        </p:nvSpPr>
        <p:spPr>
          <a:xfrm>
            <a:off x="1976814" y="296592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dirty="0">
                <a:latin typeface="Helvetica" pitchFamily="2" charset="0"/>
              </a:rPr>
              <a:t>d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63A2D529-7D3A-5604-9E8E-E1D7E749C9A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16006" y="765679"/>
            <a:ext cx="2582803" cy="222430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DEA816D-63C0-2FC3-D0FE-E8EA5EA1C525}"/>
              </a:ext>
            </a:extLst>
          </p:cNvPr>
          <p:cNvSpPr txBox="1"/>
          <p:nvPr/>
        </p:nvSpPr>
        <p:spPr>
          <a:xfrm>
            <a:off x="4448228" y="524133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dirty="0">
                <a:latin typeface="Helvetica" pitchFamily="2" charset="0"/>
              </a:rPr>
              <a:t>h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B3E946FF-1629-7184-0048-E1F11BE19C4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532667" y="5499829"/>
            <a:ext cx="2363706" cy="2209071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8FB8284C-6D51-5342-7DCC-C9740AD64B7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70542" y="5436553"/>
            <a:ext cx="2070711" cy="19816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10546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Picture 50">
            <a:extLst>
              <a:ext uri="{FF2B5EF4-FFF2-40B4-BE49-F238E27FC236}">
                <a16:creationId xmlns:a16="http://schemas.microsoft.com/office/drawing/2014/main" id="{5256B401-30A1-4928-2FCF-BB17516D6A1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flipH="1">
            <a:off x="1488503" y="2790952"/>
            <a:ext cx="2586996" cy="1893669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2FD99C36-CD66-F977-ED8A-0989B866B3B8}"/>
              </a:ext>
            </a:extLst>
          </p:cNvPr>
          <p:cNvSpPr txBox="1"/>
          <p:nvPr/>
        </p:nvSpPr>
        <p:spPr>
          <a:xfrm>
            <a:off x="1608728" y="3602173"/>
            <a:ext cx="528236" cy="2903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VMH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E051EB9A-8421-BDAE-A3BD-2BE1FB449F08}"/>
              </a:ext>
            </a:extLst>
          </p:cNvPr>
          <p:cNvSpPr txBox="1"/>
          <p:nvPr/>
        </p:nvSpPr>
        <p:spPr>
          <a:xfrm>
            <a:off x="1976709" y="2754560"/>
            <a:ext cx="535111" cy="2903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DMH</a:t>
            </a:r>
          </a:p>
        </p:txBody>
      </p:sp>
      <p:sp>
        <p:nvSpPr>
          <p:cNvPr id="54" name="Freeform 53">
            <a:extLst>
              <a:ext uri="{FF2B5EF4-FFF2-40B4-BE49-F238E27FC236}">
                <a16:creationId xmlns:a16="http://schemas.microsoft.com/office/drawing/2014/main" id="{272E69FB-D265-8F5D-F62B-2B3D413354D4}"/>
              </a:ext>
            </a:extLst>
          </p:cNvPr>
          <p:cNvSpPr/>
          <p:nvPr/>
        </p:nvSpPr>
        <p:spPr>
          <a:xfrm>
            <a:off x="1545576" y="3858938"/>
            <a:ext cx="1135993" cy="665687"/>
          </a:xfrm>
          <a:custGeom>
            <a:avLst/>
            <a:gdLst>
              <a:gd name="connsiteX0" fmla="*/ 0 w 1299411"/>
              <a:gd name="connsiteY0" fmla="*/ 18089 h 752015"/>
              <a:gd name="connsiteX1" fmla="*/ 553453 w 1299411"/>
              <a:gd name="connsiteY1" fmla="*/ 6057 h 752015"/>
              <a:gd name="connsiteX2" fmla="*/ 1155032 w 1299411"/>
              <a:gd name="connsiteY2" fmla="*/ 102310 h 752015"/>
              <a:gd name="connsiteX3" fmla="*/ 1299411 w 1299411"/>
              <a:gd name="connsiteY3" fmla="*/ 752015 h 75201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299411" h="752015">
                <a:moveTo>
                  <a:pt x="0" y="18089"/>
                </a:moveTo>
                <a:cubicBezTo>
                  <a:pt x="180474" y="5054"/>
                  <a:pt x="360948" y="-7980"/>
                  <a:pt x="553453" y="6057"/>
                </a:cubicBezTo>
                <a:cubicBezTo>
                  <a:pt x="745958" y="20094"/>
                  <a:pt x="1030706" y="-22016"/>
                  <a:pt x="1155032" y="102310"/>
                </a:cubicBezTo>
                <a:cubicBezTo>
                  <a:pt x="1279358" y="226636"/>
                  <a:pt x="1289384" y="489325"/>
                  <a:pt x="1299411" y="752015"/>
                </a:cubicBezTo>
              </a:path>
            </a:pathLst>
          </a:cu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Freeform 54">
            <a:extLst>
              <a:ext uri="{FF2B5EF4-FFF2-40B4-BE49-F238E27FC236}">
                <a16:creationId xmlns:a16="http://schemas.microsoft.com/office/drawing/2014/main" id="{E19E4F1A-BFF0-E949-2DDD-7B9DD36DEF8A}"/>
              </a:ext>
            </a:extLst>
          </p:cNvPr>
          <p:cNvSpPr/>
          <p:nvPr/>
        </p:nvSpPr>
        <p:spPr>
          <a:xfrm>
            <a:off x="2473268" y="2850727"/>
            <a:ext cx="950165" cy="798406"/>
          </a:xfrm>
          <a:custGeom>
            <a:avLst/>
            <a:gdLst>
              <a:gd name="connsiteX0" fmla="*/ 732693 w 840977"/>
              <a:gd name="connsiteY0" fmla="*/ 0 h 901945"/>
              <a:gd name="connsiteX1" fmla="*/ 119083 w 840977"/>
              <a:gd name="connsiteY1" fmla="*/ 84221 h 901945"/>
              <a:gd name="connsiteX2" fmla="*/ 22830 w 840977"/>
              <a:gd name="connsiteY2" fmla="*/ 421105 h 901945"/>
              <a:gd name="connsiteX3" fmla="*/ 407840 w 840977"/>
              <a:gd name="connsiteY3" fmla="*/ 866274 h 901945"/>
              <a:gd name="connsiteX4" fmla="*/ 840977 w 840977"/>
              <a:gd name="connsiteY4" fmla="*/ 842211 h 90194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40977" h="901945">
                <a:moveTo>
                  <a:pt x="732693" y="0"/>
                </a:moveTo>
                <a:cubicBezTo>
                  <a:pt x="485043" y="7018"/>
                  <a:pt x="237393" y="14037"/>
                  <a:pt x="119083" y="84221"/>
                </a:cubicBezTo>
                <a:cubicBezTo>
                  <a:pt x="773" y="154405"/>
                  <a:pt x="-25296" y="290763"/>
                  <a:pt x="22830" y="421105"/>
                </a:cubicBezTo>
                <a:cubicBezTo>
                  <a:pt x="70956" y="551447"/>
                  <a:pt x="271482" y="796090"/>
                  <a:pt x="407840" y="866274"/>
                </a:cubicBezTo>
                <a:cubicBezTo>
                  <a:pt x="544198" y="936458"/>
                  <a:pt x="692587" y="889334"/>
                  <a:pt x="840977" y="842211"/>
                </a:cubicBezTo>
              </a:path>
            </a:pathLst>
          </a:cu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EA996CB-BFFB-0732-F2EA-6C79B245DC24}"/>
              </a:ext>
            </a:extLst>
          </p:cNvPr>
          <p:cNvSpPr txBox="1"/>
          <p:nvPr/>
        </p:nvSpPr>
        <p:spPr>
          <a:xfrm>
            <a:off x="1452004" y="2776389"/>
            <a:ext cx="6181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rgbClr val="17FF0D"/>
                </a:solidFill>
              </a:rPr>
              <a:t>c-Fos</a:t>
            </a:r>
          </a:p>
        </p:txBody>
      </p:sp>
      <p:pic>
        <p:nvPicPr>
          <p:cNvPr id="57" name="Picture 56">
            <a:extLst>
              <a:ext uri="{FF2B5EF4-FFF2-40B4-BE49-F238E27FC236}">
                <a16:creationId xmlns:a16="http://schemas.microsoft.com/office/drawing/2014/main" id="{942F1A97-AB93-939A-66A1-ADBAAC252A3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485664" y="833099"/>
            <a:ext cx="2592476" cy="1937480"/>
          </a:xfrm>
          <a:prstGeom prst="rect">
            <a:avLst/>
          </a:prstGeom>
        </p:spPr>
      </p:pic>
      <p:sp>
        <p:nvSpPr>
          <p:cNvPr id="58" name="TextBox 57">
            <a:extLst>
              <a:ext uri="{FF2B5EF4-FFF2-40B4-BE49-F238E27FC236}">
                <a16:creationId xmlns:a16="http://schemas.microsoft.com/office/drawing/2014/main" id="{C933046C-DF84-A1DA-0EA2-4D84355542DB}"/>
              </a:ext>
            </a:extLst>
          </p:cNvPr>
          <p:cNvSpPr txBox="1"/>
          <p:nvPr/>
        </p:nvSpPr>
        <p:spPr>
          <a:xfrm>
            <a:off x="1889231" y="1465966"/>
            <a:ext cx="528236" cy="2903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VMH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C21A1BB-6374-92C5-BCC6-426BA6C44F09}"/>
              </a:ext>
            </a:extLst>
          </p:cNvPr>
          <p:cNvSpPr txBox="1"/>
          <p:nvPr/>
        </p:nvSpPr>
        <p:spPr>
          <a:xfrm>
            <a:off x="2049053" y="814489"/>
            <a:ext cx="535111" cy="2903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DMH</a:t>
            </a:r>
          </a:p>
        </p:txBody>
      </p:sp>
      <p:sp>
        <p:nvSpPr>
          <p:cNvPr id="60" name="Freeform 59">
            <a:extLst>
              <a:ext uri="{FF2B5EF4-FFF2-40B4-BE49-F238E27FC236}">
                <a16:creationId xmlns:a16="http://schemas.microsoft.com/office/drawing/2014/main" id="{60ACE533-FAB1-1A73-F75C-857F9EF17C96}"/>
              </a:ext>
            </a:extLst>
          </p:cNvPr>
          <p:cNvSpPr/>
          <p:nvPr/>
        </p:nvSpPr>
        <p:spPr>
          <a:xfrm>
            <a:off x="1700554" y="1705687"/>
            <a:ext cx="1118952" cy="681088"/>
          </a:xfrm>
          <a:custGeom>
            <a:avLst/>
            <a:gdLst>
              <a:gd name="connsiteX0" fmla="*/ 0 w 1299411"/>
              <a:gd name="connsiteY0" fmla="*/ 18089 h 752015"/>
              <a:gd name="connsiteX1" fmla="*/ 553453 w 1299411"/>
              <a:gd name="connsiteY1" fmla="*/ 6057 h 752015"/>
              <a:gd name="connsiteX2" fmla="*/ 1155032 w 1299411"/>
              <a:gd name="connsiteY2" fmla="*/ 102310 h 752015"/>
              <a:gd name="connsiteX3" fmla="*/ 1299411 w 1299411"/>
              <a:gd name="connsiteY3" fmla="*/ 752015 h 75201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299411" h="752015">
                <a:moveTo>
                  <a:pt x="0" y="18089"/>
                </a:moveTo>
                <a:cubicBezTo>
                  <a:pt x="180474" y="5054"/>
                  <a:pt x="360948" y="-7980"/>
                  <a:pt x="553453" y="6057"/>
                </a:cubicBezTo>
                <a:cubicBezTo>
                  <a:pt x="745958" y="20094"/>
                  <a:pt x="1030706" y="-22016"/>
                  <a:pt x="1155032" y="102310"/>
                </a:cubicBezTo>
                <a:cubicBezTo>
                  <a:pt x="1279358" y="226636"/>
                  <a:pt x="1289384" y="489325"/>
                  <a:pt x="1299411" y="752015"/>
                </a:cubicBezTo>
              </a:path>
            </a:pathLst>
          </a:cu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Freeform 60">
            <a:extLst>
              <a:ext uri="{FF2B5EF4-FFF2-40B4-BE49-F238E27FC236}">
                <a16:creationId xmlns:a16="http://schemas.microsoft.com/office/drawing/2014/main" id="{71FED07E-1025-7A07-6E22-6C27771898CC}"/>
              </a:ext>
            </a:extLst>
          </p:cNvPr>
          <p:cNvSpPr/>
          <p:nvPr/>
        </p:nvSpPr>
        <p:spPr>
          <a:xfrm>
            <a:off x="2475295" y="886643"/>
            <a:ext cx="840975" cy="816878"/>
          </a:xfrm>
          <a:custGeom>
            <a:avLst/>
            <a:gdLst>
              <a:gd name="connsiteX0" fmla="*/ 732693 w 840977"/>
              <a:gd name="connsiteY0" fmla="*/ 0 h 901945"/>
              <a:gd name="connsiteX1" fmla="*/ 119083 w 840977"/>
              <a:gd name="connsiteY1" fmla="*/ 84221 h 901945"/>
              <a:gd name="connsiteX2" fmla="*/ 22830 w 840977"/>
              <a:gd name="connsiteY2" fmla="*/ 421105 h 901945"/>
              <a:gd name="connsiteX3" fmla="*/ 407840 w 840977"/>
              <a:gd name="connsiteY3" fmla="*/ 866274 h 901945"/>
              <a:gd name="connsiteX4" fmla="*/ 840977 w 840977"/>
              <a:gd name="connsiteY4" fmla="*/ 842211 h 90194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40977" h="901945">
                <a:moveTo>
                  <a:pt x="732693" y="0"/>
                </a:moveTo>
                <a:cubicBezTo>
                  <a:pt x="485043" y="7018"/>
                  <a:pt x="237393" y="14037"/>
                  <a:pt x="119083" y="84221"/>
                </a:cubicBezTo>
                <a:cubicBezTo>
                  <a:pt x="773" y="154405"/>
                  <a:pt x="-25296" y="290763"/>
                  <a:pt x="22830" y="421105"/>
                </a:cubicBezTo>
                <a:cubicBezTo>
                  <a:pt x="70956" y="551447"/>
                  <a:pt x="271482" y="796090"/>
                  <a:pt x="407840" y="866274"/>
                </a:cubicBezTo>
                <a:cubicBezTo>
                  <a:pt x="544198" y="936458"/>
                  <a:pt x="692587" y="889334"/>
                  <a:pt x="840977" y="842211"/>
                </a:cubicBezTo>
              </a:path>
            </a:pathLst>
          </a:cu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2563C314-6600-3E22-A277-19221F102DF5}"/>
              </a:ext>
            </a:extLst>
          </p:cNvPr>
          <p:cNvSpPr txBox="1"/>
          <p:nvPr/>
        </p:nvSpPr>
        <p:spPr>
          <a:xfrm>
            <a:off x="1560897" y="817803"/>
            <a:ext cx="6181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rgbClr val="17FF0D"/>
                </a:solidFill>
              </a:rPr>
              <a:t>c-Fos</a:t>
            </a:r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FF7EB20E-7EDD-8C4F-6C4B-CFFE3B2ACB7C}"/>
              </a:ext>
            </a:extLst>
          </p:cNvPr>
          <p:cNvCxnSpPr>
            <a:cxnSpLocks/>
          </p:cNvCxnSpPr>
          <p:nvPr/>
        </p:nvCxnSpPr>
        <p:spPr>
          <a:xfrm>
            <a:off x="1582487" y="4590422"/>
            <a:ext cx="17599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7E10931C-365F-DDA5-DDDB-4610C9855A81}"/>
              </a:ext>
            </a:extLst>
          </p:cNvPr>
          <p:cNvSpPr txBox="1"/>
          <p:nvPr/>
        </p:nvSpPr>
        <p:spPr>
          <a:xfrm>
            <a:off x="1502423" y="4407482"/>
            <a:ext cx="3962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solidFill>
                  <a:schemeClr val="bg1"/>
                </a:solidFill>
              </a:rPr>
              <a:t>50μm</a:t>
            </a:r>
            <a:endParaRPr lang="en-US" sz="700" dirty="0">
              <a:solidFill>
                <a:schemeClr val="bg1"/>
              </a:solidFill>
            </a:endParaRP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BCED3D62-5BB4-0563-A5A9-1768F30CCC4B}"/>
              </a:ext>
            </a:extLst>
          </p:cNvPr>
          <p:cNvCxnSpPr>
            <a:cxnSpLocks/>
          </p:cNvCxnSpPr>
          <p:nvPr/>
        </p:nvCxnSpPr>
        <p:spPr>
          <a:xfrm>
            <a:off x="1573617" y="2659247"/>
            <a:ext cx="17599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C97B1DC7-AC30-D926-1C14-B44AD6F04321}"/>
              </a:ext>
            </a:extLst>
          </p:cNvPr>
          <p:cNvSpPr txBox="1"/>
          <p:nvPr/>
        </p:nvSpPr>
        <p:spPr>
          <a:xfrm>
            <a:off x="1493553" y="2476307"/>
            <a:ext cx="3962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solidFill>
                  <a:schemeClr val="bg1"/>
                </a:solidFill>
              </a:rPr>
              <a:t>50μm</a:t>
            </a:r>
            <a:endParaRPr lang="en-US" sz="700" dirty="0">
              <a:solidFill>
                <a:schemeClr val="bg1"/>
              </a:solidFill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72795613-03BE-25EC-9359-026F1F297267}"/>
              </a:ext>
            </a:extLst>
          </p:cNvPr>
          <p:cNvSpPr txBox="1"/>
          <p:nvPr/>
        </p:nvSpPr>
        <p:spPr>
          <a:xfrm>
            <a:off x="3188901" y="2046231"/>
            <a:ext cx="4366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solidFill>
                  <a:schemeClr val="bg1"/>
                </a:solidFill>
              </a:rPr>
              <a:t>3V</a:t>
            </a:r>
            <a:endParaRPr lang="en-US" sz="1400" dirty="0">
              <a:solidFill>
                <a:schemeClr val="bg1"/>
              </a:solidFill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F400D94F-DFF4-D212-1C20-5165AD9C362F}"/>
              </a:ext>
            </a:extLst>
          </p:cNvPr>
          <p:cNvSpPr txBox="1"/>
          <p:nvPr/>
        </p:nvSpPr>
        <p:spPr>
          <a:xfrm>
            <a:off x="3421359" y="3944030"/>
            <a:ext cx="4366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solidFill>
                  <a:schemeClr val="bg1"/>
                </a:solidFill>
              </a:rPr>
              <a:t>3V</a:t>
            </a:r>
            <a:endParaRPr lang="en-US" sz="1400" dirty="0">
              <a:solidFill>
                <a:schemeClr val="bg1"/>
              </a:solidFill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8D48A0EA-5C64-4E7D-7DFF-70C5358CECDD}"/>
              </a:ext>
            </a:extLst>
          </p:cNvPr>
          <p:cNvSpPr txBox="1"/>
          <p:nvPr/>
        </p:nvSpPr>
        <p:spPr>
          <a:xfrm>
            <a:off x="167703" y="141496"/>
            <a:ext cx="18854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400" dirty="0">
                <a:latin typeface="Helvetica" pitchFamily="2" charset="0"/>
              </a:rPr>
              <a:t>Supplementary Fig. 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5FE2996-BAB8-B0D5-E64B-BD5F0606ECD2}"/>
              </a:ext>
            </a:extLst>
          </p:cNvPr>
          <p:cNvSpPr txBox="1"/>
          <p:nvPr/>
        </p:nvSpPr>
        <p:spPr>
          <a:xfrm rot="16200000">
            <a:off x="817931" y="1681858"/>
            <a:ext cx="8851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Helvetica" pitchFamily="2" charset="0"/>
              </a:rPr>
              <a:t>Flox-PKC</a:t>
            </a:r>
            <a:r>
              <a:rPr lang="en-US" sz="1100" b="1" dirty="0">
                <a:latin typeface="Symbol" pitchFamily="2" charset="2"/>
              </a:rPr>
              <a:t>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DCEDC9B-95CC-6DD2-5AE9-E76C809D40ED}"/>
              </a:ext>
            </a:extLst>
          </p:cNvPr>
          <p:cNvSpPr txBox="1"/>
          <p:nvPr/>
        </p:nvSpPr>
        <p:spPr>
          <a:xfrm rot="16200000">
            <a:off x="650085" y="3660964"/>
            <a:ext cx="12314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Helvetica" pitchFamily="2" charset="0"/>
              </a:rPr>
              <a:t>AgRP-PKC</a:t>
            </a:r>
            <a:r>
              <a:rPr lang="en-US" sz="1100" b="1" dirty="0">
                <a:latin typeface="Symbol" pitchFamily="2" charset="2"/>
              </a:rPr>
              <a:t></a:t>
            </a:r>
            <a:r>
              <a:rPr lang="en-US" sz="1100" b="1" dirty="0">
                <a:latin typeface="Helvetica" pitchFamily="2" charset="0"/>
              </a:rPr>
              <a:t> KO</a:t>
            </a:r>
            <a:endParaRPr lang="en-US" sz="1100" b="1" dirty="0">
              <a:latin typeface="Symbol" pitchFamily="2" charset="2"/>
            </a:endParaRPr>
          </a:p>
        </p:txBody>
      </p:sp>
    </p:spTree>
    <p:extLst>
      <p:ext uri="{BB962C8B-B14F-4D97-AF65-F5344CB8AC3E}">
        <p14:creationId xmlns:p14="http://schemas.microsoft.com/office/powerpoint/2010/main" val="20402067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D3D5939-0D72-311C-9099-5717FF2D2A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53788" y="1662090"/>
            <a:ext cx="1590554" cy="1432290"/>
          </a:xfrm>
          <a:prstGeom prst="rect">
            <a:avLst/>
          </a:prstGeom>
        </p:spPr>
      </p:pic>
      <p:grpSp>
        <p:nvGrpSpPr>
          <p:cNvPr id="39" name="Group 38">
            <a:extLst>
              <a:ext uri="{FF2B5EF4-FFF2-40B4-BE49-F238E27FC236}">
                <a16:creationId xmlns:a16="http://schemas.microsoft.com/office/drawing/2014/main" id="{159913AA-480D-2C51-7B49-9645577EF7ED}"/>
              </a:ext>
            </a:extLst>
          </p:cNvPr>
          <p:cNvGrpSpPr/>
          <p:nvPr/>
        </p:nvGrpSpPr>
        <p:grpSpPr>
          <a:xfrm>
            <a:off x="3278706" y="841189"/>
            <a:ext cx="1750253" cy="649752"/>
            <a:chOff x="3443043" y="3847300"/>
            <a:chExt cx="2543074" cy="944073"/>
          </a:xfrm>
        </p:grpSpPr>
        <p:pic>
          <p:nvPicPr>
            <p:cNvPr id="9" name="Picture 8" descr="A black line on a white background&#10;&#10;AI-generated content may be incorrect.">
              <a:extLst>
                <a:ext uri="{FF2B5EF4-FFF2-40B4-BE49-F238E27FC236}">
                  <a16:creationId xmlns:a16="http://schemas.microsoft.com/office/drawing/2014/main" id="{5A5AF88A-EA78-9F7B-6DB3-2FB5A256FB3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90125" y="4498298"/>
              <a:ext cx="1562100" cy="2794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" name="Picture 10" descr="Blur blurry black and white image&#10;&#10;AI-generated content may be incorrect.">
              <a:extLst>
                <a:ext uri="{FF2B5EF4-FFF2-40B4-BE49-F238E27FC236}">
                  <a16:creationId xmlns:a16="http://schemas.microsoft.com/office/drawing/2014/main" id="{5A6923FE-D412-B046-2A22-D5597BACBE7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290125" y="4086382"/>
              <a:ext cx="1587500" cy="2921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36DDC1C-A06E-1538-910B-3F68E5A96E2F}"/>
                </a:ext>
              </a:extLst>
            </p:cNvPr>
            <p:cNvSpPr txBox="1"/>
            <p:nvPr/>
          </p:nvSpPr>
          <p:spPr>
            <a:xfrm>
              <a:off x="3581414" y="4128007"/>
              <a:ext cx="657279" cy="290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Helvetica" pitchFamily="2" charset="0"/>
                </a:rPr>
                <a:t>UCP-1</a:t>
              </a:r>
              <a:endParaRPr lang="en-US" sz="1000" b="1" dirty="0">
                <a:latin typeface="Helvetica" pitchFamily="2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0E45ABA-342F-95B7-7E02-0C0FBA487953}"/>
                </a:ext>
              </a:extLst>
            </p:cNvPr>
            <p:cNvSpPr txBox="1"/>
            <p:nvPr/>
          </p:nvSpPr>
          <p:spPr>
            <a:xfrm>
              <a:off x="3443043" y="4500698"/>
              <a:ext cx="776065" cy="290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Helvetica" pitchFamily="2" charset="0"/>
                </a:rPr>
                <a:t>Vinculin</a:t>
              </a:r>
              <a:endParaRPr lang="en-US" sz="1000" b="1" dirty="0">
                <a:latin typeface="Helvetica" pitchFamily="2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68CE4D8-23E0-E1CB-EC0F-1E4F46B4BE16}"/>
                </a:ext>
              </a:extLst>
            </p:cNvPr>
            <p:cNvSpPr txBox="1"/>
            <p:nvPr/>
          </p:nvSpPr>
          <p:spPr>
            <a:xfrm>
              <a:off x="4181632" y="3847300"/>
              <a:ext cx="180448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>
                  <a:latin typeface="Helvetica" pitchFamily="2" charset="0"/>
                </a:rPr>
                <a:t>Flox</a:t>
              </a:r>
              <a:r>
                <a:rPr lang="en-US" sz="700" dirty="0">
                  <a:latin typeface="Helvetica" pitchFamily="2" charset="0"/>
                </a:rPr>
                <a:t> KO </a:t>
              </a:r>
              <a:r>
                <a:rPr lang="en-US" sz="700" dirty="0" err="1">
                  <a:latin typeface="Helvetica" pitchFamily="2" charset="0"/>
                </a:rPr>
                <a:t>Flox</a:t>
              </a:r>
              <a:r>
                <a:rPr lang="en-US" sz="700" dirty="0">
                  <a:latin typeface="Helvetica" pitchFamily="2" charset="0"/>
                </a:rPr>
                <a:t> KO </a:t>
              </a:r>
              <a:r>
                <a:rPr lang="en-US" sz="700" dirty="0" err="1">
                  <a:latin typeface="Helvetica" pitchFamily="2" charset="0"/>
                </a:rPr>
                <a:t>Flox</a:t>
              </a:r>
              <a:r>
                <a:rPr lang="en-US" sz="700" dirty="0">
                  <a:latin typeface="Helvetica" pitchFamily="2" charset="0"/>
                </a:rPr>
                <a:t> KO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08932C44-6078-9E57-0C4A-B1629AF7EC4C}"/>
              </a:ext>
            </a:extLst>
          </p:cNvPr>
          <p:cNvSpPr txBox="1"/>
          <p:nvPr/>
        </p:nvSpPr>
        <p:spPr>
          <a:xfrm>
            <a:off x="183041" y="3453441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D268DAC-EB85-A6D8-5E77-26AD807244D1}"/>
              </a:ext>
            </a:extLst>
          </p:cNvPr>
          <p:cNvSpPr txBox="1"/>
          <p:nvPr/>
        </p:nvSpPr>
        <p:spPr>
          <a:xfrm>
            <a:off x="202883" y="753708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52A53E8-E5F4-5412-4E4B-95A67600BBAF}"/>
              </a:ext>
            </a:extLst>
          </p:cNvPr>
          <p:cNvSpPr txBox="1"/>
          <p:nvPr/>
        </p:nvSpPr>
        <p:spPr>
          <a:xfrm>
            <a:off x="3143436" y="75370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98E9D53-BB83-4A4F-E374-739054FA765F}"/>
              </a:ext>
            </a:extLst>
          </p:cNvPr>
          <p:cNvSpPr txBox="1"/>
          <p:nvPr/>
        </p:nvSpPr>
        <p:spPr>
          <a:xfrm>
            <a:off x="3151903" y="343923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BB2ADE13-4CC3-8F02-5041-DFBEAB3DE5E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20188" y="1684014"/>
            <a:ext cx="1527135" cy="1396017"/>
          </a:xfrm>
          <a:prstGeom prst="rect">
            <a:avLst/>
          </a:prstGeom>
        </p:spPr>
      </p:pic>
      <p:grpSp>
        <p:nvGrpSpPr>
          <p:cNvPr id="22" name="Group 21">
            <a:extLst>
              <a:ext uri="{FF2B5EF4-FFF2-40B4-BE49-F238E27FC236}">
                <a16:creationId xmlns:a16="http://schemas.microsoft.com/office/drawing/2014/main" id="{D472545E-1F88-A44A-6B6A-9191D9A15449}"/>
              </a:ext>
            </a:extLst>
          </p:cNvPr>
          <p:cNvGrpSpPr/>
          <p:nvPr/>
        </p:nvGrpSpPr>
        <p:grpSpPr>
          <a:xfrm>
            <a:off x="1871082" y="1372084"/>
            <a:ext cx="1152985" cy="276999"/>
            <a:chOff x="8190284" y="9709"/>
            <a:chExt cx="1152985" cy="276999"/>
          </a:xfrm>
        </p:grpSpPr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82A68575-1EFD-DEB0-F392-08F226F6BFC2}"/>
                </a:ext>
              </a:extLst>
            </p:cNvPr>
            <p:cNvSpPr/>
            <p:nvPr/>
          </p:nvSpPr>
          <p:spPr>
            <a:xfrm>
              <a:off x="8808402" y="90180"/>
              <a:ext cx="116057" cy="116057"/>
            </a:xfrm>
            <a:prstGeom prst="rect">
              <a:avLst/>
            </a:prstGeom>
            <a:solidFill>
              <a:srgbClr val="8EFA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A96C99BE-9694-DB00-20EB-2488DB54B784}"/>
                </a:ext>
              </a:extLst>
            </p:cNvPr>
            <p:cNvSpPr/>
            <p:nvPr/>
          </p:nvSpPr>
          <p:spPr>
            <a:xfrm>
              <a:off x="8190284" y="90180"/>
              <a:ext cx="116057" cy="116057"/>
            </a:xfrm>
            <a:prstGeom prst="rect">
              <a:avLst/>
            </a:prstGeom>
            <a:solidFill>
              <a:srgbClr val="9411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10BBFBA3-DD24-84D0-91DA-5C24BE36997D}"/>
                </a:ext>
              </a:extLst>
            </p:cNvPr>
            <p:cNvSpPr txBox="1"/>
            <p:nvPr/>
          </p:nvSpPr>
          <p:spPr>
            <a:xfrm>
              <a:off x="8306341" y="9709"/>
              <a:ext cx="5020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>
                  <a:latin typeface="Helvetica" pitchFamily="2" charset="0"/>
                </a:rPr>
                <a:t>Flox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AB9D3D7D-CA96-10F1-83C4-2C3FFC37B1AF}"/>
                </a:ext>
              </a:extLst>
            </p:cNvPr>
            <p:cNvSpPr txBox="1"/>
            <p:nvPr/>
          </p:nvSpPr>
          <p:spPr>
            <a:xfrm>
              <a:off x="8927771" y="9709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>
                  <a:latin typeface="Helvetica" pitchFamily="2" charset="0"/>
                </a:rPr>
                <a:t>KO</a:t>
              </a:r>
            </a:p>
          </p:txBody>
        </p:sp>
      </p:grpSp>
      <p:sp>
        <p:nvSpPr>
          <p:cNvPr id="27" name="TextBox 26">
            <a:extLst>
              <a:ext uri="{FF2B5EF4-FFF2-40B4-BE49-F238E27FC236}">
                <a16:creationId xmlns:a16="http://schemas.microsoft.com/office/drawing/2014/main" id="{C0EDEC0A-3BAB-688D-0C23-B82762DB6598}"/>
              </a:ext>
            </a:extLst>
          </p:cNvPr>
          <p:cNvSpPr txBox="1"/>
          <p:nvPr/>
        </p:nvSpPr>
        <p:spPr>
          <a:xfrm>
            <a:off x="1093492" y="1356694"/>
            <a:ext cx="616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 pitchFamily="2" charset="0"/>
              </a:rPr>
              <a:t>BAT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68A17572-24B0-1962-CA46-3971F322E89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6338" y="1495926"/>
            <a:ext cx="3218251" cy="1600136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676365CE-BABF-5D5D-DF32-1E0284E5008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42675" y="4518543"/>
            <a:ext cx="1411615" cy="1396017"/>
          </a:xfrm>
          <a:prstGeom prst="rect">
            <a:avLst/>
          </a:prstGeom>
        </p:spPr>
      </p:pic>
      <p:grpSp>
        <p:nvGrpSpPr>
          <p:cNvPr id="30" name="Group 29">
            <a:extLst>
              <a:ext uri="{FF2B5EF4-FFF2-40B4-BE49-F238E27FC236}">
                <a16:creationId xmlns:a16="http://schemas.microsoft.com/office/drawing/2014/main" id="{62CFDD48-7534-2838-2C03-77E256AE7575}"/>
              </a:ext>
            </a:extLst>
          </p:cNvPr>
          <p:cNvGrpSpPr/>
          <p:nvPr/>
        </p:nvGrpSpPr>
        <p:grpSpPr>
          <a:xfrm>
            <a:off x="3391455" y="3604807"/>
            <a:ext cx="1761309" cy="758617"/>
            <a:chOff x="3001187" y="-218281"/>
            <a:chExt cx="2619282" cy="856256"/>
          </a:xfrm>
        </p:grpSpPr>
        <p:pic>
          <p:nvPicPr>
            <p:cNvPr id="31" name="Picture 30" descr="A blurry image of a person's face&#10;&#10;AI-generated content may be incorrect.">
              <a:extLst>
                <a:ext uri="{FF2B5EF4-FFF2-40B4-BE49-F238E27FC236}">
                  <a16:creationId xmlns:a16="http://schemas.microsoft.com/office/drawing/2014/main" id="{672ECDED-0DF3-7AD2-2778-5C5544479C1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750674" y="-14013"/>
              <a:ext cx="1600200" cy="2286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2" name="Picture 31" descr="A black line on a white surface&#10;&#10;AI-generated content may be incorrect.">
              <a:extLst>
                <a:ext uri="{FF2B5EF4-FFF2-40B4-BE49-F238E27FC236}">
                  <a16:creationId xmlns:a16="http://schemas.microsoft.com/office/drawing/2014/main" id="{CD672B34-7DF2-9362-CE02-9F5DBE554C78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750674" y="356278"/>
              <a:ext cx="1600200" cy="25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57B9A777-B05B-949B-B995-FFEF953697AC}"/>
                </a:ext>
              </a:extLst>
            </p:cNvPr>
            <p:cNvSpPr txBox="1"/>
            <p:nvPr/>
          </p:nvSpPr>
          <p:spPr>
            <a:xfrm>
              <a:off x="3126660" y="-14012"/>
              <a:ext cx="688986" cy="304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Helvetica" pitchFamily="2" charset="0"/>
                </a:rPr>
                <a:t>UCP-1</a:t>
              </a:r>
              <a:endParaRPr lang="en-US" sz="1000" b="1" dirty="0">
                <a:latin typeface="Helvetica" pitchFamily="2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6CE36519-7A32-1965-75CB-3130D93966E1}"/>
                </a:ext>
              </a:extLst>
            </p:cNvPr>
            <p:cNvSpPr txBox="1"/>
            <p:nvPr/>
          </p:nvSpPr>
          <p:spPr>
            <a:xfrm>
              <a:off x="3001187" y="333278"/>
              <a:ext cx="813500" cy="304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Helvetica" pitchFamily="2" charset="0"/>
                </a:rPr>
                <a:t>Vinculin</a:t>
              </a:r>
              <a:endParaRPr lang="en-US" sz="1000" b="1" dirty="0">
                <a:latin typeface="Helvetica" pitchFamily="2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7EEE7050-C583-6FF2-E685-532CA4473805}"/>
                </a:ext>
              </a:extLst>
            </p:cNvPr>
            <p:cNvSpPr txBox="1"/>
            <p:nvPr/>
          </p:nvSpPr>
          <p:spPr>
            <a:xfrm>
              <a:off x="3630771" y="-218281"/>
              <a:ext cx="1989698" cy="3046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>
                  <a:latin typeface="Helvetica" pitchFamily="2" charset="0"/>
                </a:rPr>
                <a:t>Flox</a:t>
              </a:r>
              <a:r>
                <a:rPr lang="en-US" sz="700" dirty="0">
                  <a:latin typeface="Helvetica" pitchFamily="2" charset="0"/>
                </a:rPr>
                <a:t> KO </a:t>
              </a:r>
              <a:r>
                <a:rPr lang="en-US" sz="700" dirty="0" err="1">
                  <a:latin typeface="Helvetica" pitchFamily="2" charset="0"/>
                </a:rPr>
                <a:t>Flox</a:t>
              </a:r>
              <a:r>
                <a:rPr lang="en-US" sz="700" dirty="0">
                  <a:latin typeface="Helvetica" pitchFamily="2" charset="0"/>
                </a:rPr>
                <a:t> KO </a:t>
              </a:r>
              <a:r>
                <a:rPr lang="en-US" sz="700" dirty="0" err="1">
                  <a:latin typeface="Helvetica" pitchFamily="2" charset="0"/>
                </a:rPr>
                <a:t>Flox</a:t>
              </a:r>
              <a:r>
                <a:rPr lang="en-US" sz="700" dirty="0">
                  <a:latin typeface="Helvetica" pitchFamily="2" charset="0"/>
                </a:rPr>
                <a:t> KO</a:t>
              </a:r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D5447ED4-E7D8-0CCD-C7D4-56B515220274}"/>
              </a:ext>
            </a:extLst>
          </p:cNvPr>
          <p:cNvSpPr txBox="1"/>
          <p:nvPr/>
        </p:nvSpPr>
        <p:spPr>
          <a:xfrm>
            <a:off x="5093618" y="753708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10395761-CF98-BAC5-861A-924AAB2024A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70027" y="4307797"/>
            <a:ext cx="3216562" cy="1621949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8152FB4E-EE7B-DB27-AA06-025F1710A5DD}"/>
              </a:ext>
            </a:extLst>
          </p:cNvPr>
          <p:cNvSpPr txBox="1"/>
          <p:nvPr/>
        </p:nvSpPr>
        <p:spPr>
          <a:xfrm>
            <a:off x="5099984" y="3439236"/>
            <a:ext cx="306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</a:t>
            </a: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E496D9D4-4CB7-6F49-13E6-E490AAC1527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220188" y="4610638"/>
            <a:ext cx="1527135" cy="1470273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B467D9CA-EE88-4AB5-EB78-14D87FA76E22}"/>
              </a:ext>
            </a:extLst>
          </p:cNvPr>
          <p:cNvSpPr txBox="1"/>
          <p:nvPr/>
        </p:nvSpPr>
        <p:spPr>
          <a:xfrm>
            <a:off x="1065663" y="4123131"/>
            <a:ext cx="800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>
                <a:latin typeface="Helvetica" pitchFamily="2" charset="0"/>
              </a:rPr>
              <a:t>gWAT</a:t>
            </a:r>
            <a:endParaRPr lang="en-US" dirty="0">
              <a:latin typeface="Helvetica" pitchFamily="2" charset="0"/>
            </a:endParaRPr>
          </a:p>
        </p:txBody>
      </p:sp>
      <p:grpSp>
        <p:nvGrpSpPr>
          <p:cNvPr id="43" name="Group 42">
            <a:extLst>
              <a:ext uri="{FF2B5EF4-FFF2-40B4-BE49-F238E27FC236}">
                <a16:creationId xmlns:a16="http://schemas.microsoft.com/office/drawing/2014/main" id="{B5898A08-94D9-B858-8730-E2A5B7CA36C9}"/>
              </a:ext>
            </a:extLst>
          </p:cNvPr>
          <p:cNvGrpSpPr/>
          <p:nvPr/>
        </p:nvGrpSpPr>
        <p:grpSpPr>
          <a:xfrm>
            <a:off x="1871082" y="4162740"/>
            <a:ext cx="1152985" cy="276999"/>
            <a:chOff x="8190284" y="9709"/>
            <a:chExt cx="1152985" cy="276999"/>
          </a:xfrm>
        </p:grpSpPr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5A60E24A-4779-0AF1-AF05-42E790C47690}"/>
                </a:ext>
              </a:extLst>
            </p:cNvPr>
            <p:cNvSpPr/>
            <p:nvPr/>
          </p:nvSpPr>
          <p:spPr>
            <a:xfrm>
              <a:off x="8808402" y="90180"/>
              <a:ext cx="116057" cy="116057"/>
            </a:xfrm>
            <a:prstGeom prst="rect">
              <a:avLst/>
            </a:prstGeom>
            <a:solidFill>
              <a:srgbClr val="8EFA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D0FEF2E6-FD23-D595-4FCC-723DEAA2DC30}"/>
                </a:ext>
              </a:extLst>
            </p:cNvPr>
            <p:cNvSpPr/>
            <p:nvPr/>
          </p:nvSpPr>
          <p:spPr>
            <a:xfrm>
              <a:off x="8190284" y="90180"/>
              <a:ext cx="116057" cy="116057"/>
            </a:xfrm>
            <a:prstGeom prst="rect">
              <a:avLst/>
            </a:prstGeom>
            <a:solidFill>
              <a:srgbClr val="9411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B614AD4D-7E7E-B5B9-8E23-A046E7D0322C}"/>
                </a:ext>
              </a:extLst>
            </p:cNvPr>
            <p:cNvSpPr txBox="1"/>
            <p:nvPr/>
          </p:nvSpPr>
          <p:spPr>
            <a:xfrm>
              <a:off x="8306341" y="9709"/>
              <a:ext cx="5020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>
                  <a:latin typeface="Helvetica" pitchFamily="2" charset="0"/>
                </a:rPr>
                <a:t>Flox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E72EA361-9AC3-0FB0-CDC4-3C420E05D21B}"/>
                </a:ext>
              </a:extLst>
            </p:cNvPr>
            <p:cNvSpPr txBox="1"/>
            <p:nvPr/>
          </p:nvSpPr>
          <p:spPr>
            <a:xfrm>
              <a:off x="8927771" y="9709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>
                  <a:latin typeface="Helvetica" pitchFamily="2" charset="0"/>
                </a:rPr>
                <a:t>KO</a:t>
              </a:r>
            </a:p>
          </p:txBody>
        </p:sp>
      </p:grpSp>
      <p:sp>
        <p:nvSpPr>
          <p:cNvPr id="48" name="TextBox 47">
            <a:extLst>
              <a:ext uri="{FF2B5EF4-FFF2-40B4-BE49-F238E27FC236}">
                <a16:creationId xmlns:a16="http://schemas.microsoft.com/office/drawing/2014/main" id="{F69F0F0D-E254-9581-3905-EB13E8D52978}"/>
              </a:ext>
            </a:extLst>
          </p:cNvPr>
          <p:cNvSpPr txBox="1"/>
          <p:nvPr/>
        </p:nvSpPr>
        <p:spPr>
          <a:xfrm>
            <a:off x="167703" y="141496"/>
            <a:ext cx="18854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400" dirty="0">
                <a:latin typeface="Helvetica" pitchFamily="2" charset="0"/>
              </a:rPr>
              <a:t>Supplementary Fig. 4</a:t>
            </a:r>
          </a:p>
        </p:txBody>
      </p:sp>
    </p:spTree>
    <p:extLst>
      <p:ext uri="{BB962C8B-B14F-4D97-AF65-F5344CB8AC3E}">
        <p14:creationId xmlns:p14="http://schemas.microsoft.com/office/powerpoint/2010/main" val="25694286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b="1" dirty="0" smtClean="0">
            <a:latin typeface="Helvetica" pitchFamily="2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6c73c082-9ba0-4ba5-9b39-77e88cc1f494}" enabled="0" method="" siteId="{6c73c082-9ba0-4ba5-9b39-77e88cc1f494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0522</TotalTime>
  <Words>66</Words>
  <Application>Microsoft Macintosh PowerPoint</Application>
  <PresentationFormat>A4 Paper (210x297 mm)</PresentationFormat>
  <Paragraphs>4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Helvetica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sten Schmitz-Peiffer</dc:creator>
  <cp:lastModifiedBy>Carsten Schmitz-Peiffer</cp:lastModifiedBy>
  <cp:revision>77</cp:revision>
  <dcterms:created xsi:type="dcterms:W3CDTF">2022-07-22T08:06:32Z</dcterms:created>
  <dcterms:modified xsi:type="dcterms:W3CDTF">2026-01-09T23:18:10Z</dcterms:modified>
</cp:coreProperties>
</file>